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charts/colors1.xml" ContentType="application/vnd.ms-office.chartcolorstyle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3.xml" ContentType="application/vnd.ms-office.chartstyle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Default Extension="bin" ContentType="application/vnd.openxmlformats-officedocument.oleObject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8"/>
  </p:handoutMasterIdLst>
  <p:sldIdLst>
    <p:sldId id="265" r:id="rId2"/>
    <p:sldId id="267" r:id="rId3"/>
    <p:sldId id="257" r:id="rId4"/>
    <p:sldId id="258" r:id="rId5"/>
    <p:sldId id="261" r:id="rId6"/>
    <p:sldId id="268" r:id="rId7"/>
  </p:sldIdLst>
  <p:sldSz cx="12192000" cy="6858000"/>
  <p:notesSz cx="9998075" cy="68659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412" autoAdjust="0"/>
  </p:normalViewPr>
  <p:slideViewPr>
    <p:cSldViewPr snapToGrid="0">
      <p:cViewPr>
        <p:scale>
          <a:sx n="70" d="100"/>
          <a:sy n="70" d="100"/>
        </p:scale>
        <p:origin x="-702" y="-2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D:\Chemotherapy-Induced%20ROS\ELISA%20DATA\180121%20CXCL8(THP-1)%20NC,%20Gem10,%20Gem40(times%20course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D:\Chemotherapy-Induced%20ROS\ELISA%20DATA\180125%20CXCL8(THP-1)%20NC,%20Gem(dose%20test)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YJ\Desktop\transwell%20test\transwell_test(HL60_in_THP-1_sup)160311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C:\Users\YJ\Desktop\transwell%20test\transwell_test(HL60_in_THP-1_sup)160311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D:\CIN\CIN%203&#52264;\CnB%20Revision\RPMI8226%20anti-tumor%20effect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errBars>
            <c:errBarType val="both"/>
            <c:errValType val="cust"/>
            <c:plus>
              <c:numRef>
                <c:f>(Sheet2!$M$12,Sheet2!$N$12,Sheet2!$O$12,Sheet2!$Q$12)</c:f>
                <c:numCache>
                  <c:formatCode>General</c:formatCode>
                  <c:ptCount val="4"/>
                  <c:pt idx="0">
                    <c:v>1.8569680079997952</c:v>
                  </c:pt>
                  <c:pt idx="1">
                    <c:v>0.2541402596630466</c:v>
                  </c:pt>
                  <c:pt idx="2">
                    <c:v>3.1622776601683831</c:v>
                  </c:pt>
                  <c:pt idx="3">
                    <c:v>2.5155471205465405</c:v>
                  </c:pt>
                </c:numCache>
              </c:numRef>
            </c:plus>
            <c:minus>
              <c:numRef>
                <c:f>(Sheet2!$M$12,Sheet2!$N$12,Sheet2!$O$12,Sheet2!$Q$12)</c:f>
                <c:numCache>
                  <c:formatCode>General</c:formatCode>
                  <c:ptCount val="4"/>
                  <c:pt idx="0">
                    <c:v>1.8569680079997952</c:v>
                  </c:pt>
                  <c:pt idx="1">
                    <c:v>0.2541402596630466</c:v>
                  </c:pt>
                  <c:pt idx="2">
                    <c:v>3.1622776601683831</c:v>
                  </c:pt>
                  <c:pt idx="3">
                    <c:v>2.51554712054654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Sheet2!$M$2,Sheet2!$N$2,Sheet2!$O$2,Sheet2!$Q$2)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(Sheet2!$M$11,Sheet2!$N$11,Sheet2!$O$11,Sheet2!$Q$11)</c:f>
              <c:numCache>
                <c:formatCode>General</c:formatCode>
                <c:ptCount val="4"/>
                <c:pt idx="0">
                  <c:v>3.3840579710144922</c:v>
                </c:pt>
                <c:pt idx="1">
                  <c:v>7.9492753623188381</c:v>
                </c:pt>
                <c:pt idx="2">
                  <c:v>101.39130434782611</c:v>
                </c:pt>
                <c:pt idx="3">
                  <c:v>154.543478260869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82A-416A-A0FB-7A637D0FA8E8}"/>
            </c:ext>
          </c:extLst>
        </c:ser>
        <c:dLbls/>
        <c:gapWidth val="50"/>
        <c:overlap val="-27"/>
        <c:axId val="112276992"/>
        <c:axId val="112278912"/>
      </c:barChart>
      <c:catAx>
        <c:axId val="112276992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</a:t>
                </a:r>
                <a:r>
                  <a:rPr lang="en-US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h)</a:t>
                </a:r>
                <a:endParaRPr lang="ko-KR" altLang="en-US" sz="14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278912"/>
        <c:crosses val="autoZero"/>
        <c:auto val="1"/>
        <c:lblAlgn val="ctr"/>
        <c:lblOffset val="100"/>
      </c:catAx>
      <c:valAx>
        <c:axId val="11227891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XCL8</a:t>
                </a:r>
                <a:r>
                  <a:rPr lang="en-US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pg/ml)</a:t>
                </a:r>
                <a:endParaRPr lang="ko-KR" altLang="en-US" sz="14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276992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errBars>
            <c:errBarType val="both"/>
            <c:errValType val="cust"/>
            <c:plus>
              <c:numRef>
                <c:f>Sheet2!$B$20:$E$20</c:f>
                <c:numCache>
                  <c:formatCode>General</c:formatCode>
                  <c:ptCount val="4"/>
                  <c:pt idx="0">
                    <c:v>1.514375558880074</c:v>
                  </c:pt>
                  <c:pt idx="1">
                    <c:v>7.0085661871740923</c:v>
                  </c:pt>
                  <c:pt idx="2">
                    <c:v>4.2015870017569972</c:v>
                  </c:pt>
                  <c:pt idx="3">
                    <c:v>12.663859338027001</c:v>
                  </c:pt>
                </c:numCache>
              </c:numRef>
            </c:plus>
            <c:minus>
              <c:numRef>
                <c:f>Sheet2!$B$20:$E$20</c:f>
                <c:numCache>
                  <c:formatCode>General</c:formatCode>
                  <c:ptCount val="4"/>
                  <c:pt idx="0">
                    <c:v>1.514375558880074</c:v>
                  </c:pt>
                  <c:pt idx="1">
                    <c:v>7.0085661871740923</c:v>
                  </c:pt>
                  <c:pt idx="2">
                    <c:v>4.2015870017569972</c:v>
                  </c:pt>
                  <c:pt idx="3">
                    <c:v>12.66385933802700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2!$I$2:$L$2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Sheet2!$B$19:$E$19</c:f>
              <c:numCache>
                <c:formatCode>General</c:formatCode>
                <c:ptCount val="4"/>
                <c:pt idx="0">
                  <c:v>3.813333333333333</c:v>
                </c:pt>
                <c:pt idx="1">
                  <c:v>81.679999999999993</c:v>
                </c:pt>
                <c:pt idx="2">
                  <c:v>114.21333333333331</c:v>
                </c:pt>
                <c:pt idx="3">
                  <c:v>142.74666666666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B37-44F0-A517-853327E2AA59}"/>
            </c:ext>
          </c:extLst>
        </c:ser>
        <c:dLbls/>
        <c:gapWidth val="50"/>
        <c:overlap val="-27"/>
        <c:axId val="96845824"/>
        <c:axId val="96847744"/>
      </c:barChart>
      <c:catAx>
        <c:axId val="96845824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M</a:t>
                </a:r>
                <a:r>
                  <a:rPr lang="en-US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l-GR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en-US" sz="14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6847744"/>
        <c:crosses val="autoZero"/>
        <c:auto val="1"/>
        <c:lblAlgn val="ctr"/>
        <c:lblOffset val="100"/>
      </c:catAx>
      <c:valAx>
        <c:axId val="96847744"/>
        <c:scaling>
          <c:orientation val="minMax"/>
          <c:max val="18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XCL8</a:t>
                </a:r>
                <a:r>
                  <a:rPr lang="en-US" altLang="ko-KR" sz="14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pg/ml)</a:t>
                </a:r>
                <a:endParaRPr lang="ko-KR" altLang="en-US" sz="14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6845824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32644834658061317"/>
          <c:y val="0.10686135195889533"/>
          <c:w val="0.57978759587655659"/>
          <c:h val="0.74910484906872199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dose!$O$29:$R$29</c:f>
                <c:numCache>
                  <c:formatCode>General</c:formatCode>
                  <c:ptCount val="4"/>
                  <c:pt idx="0">
                    <c:v>0.25</c:v>
                  </c:pt>
                  <c:pt idx="1">
                    <c:v>0.87500000000000011</c:v>
                  </c:pt>
                  <c:pt idx="2">
                    <c:v>0.18750000000000003</c:v>
                  </c:pt>
                  <c:pt idx="3">
                    <c:v>0.75000000000000011</c:v>
                  </c:pt>
                </c:numCache>
              </c:numRef>
            </c:plus>
            <c:minus>
              <c:numRef>
                <c:f>dose!$O$29:$R$29</c:f>
                <c:numCache>
                  <c:formatCode>General</c:formatCode>
                  <c:ptCount val="4"/>
                  <c:pt idx="0">
                    <c:v>0.25</c:v>
                  </c:pt>
                  <c:pt idx="1">
                    <c:v>0.87500000000000011</c:v>
                  </c:pt>
                  <c:pt idx="2">
                    <c:v>0.18750000000000003</c:v>
                  </c:pt>
                  <c:pt idx="3">
                    <c:v>0.75000000000000011</c:v>
                  </c:pt>
                </c:numCache>
              </c:numRef>
            </c:minus>
            <c:spPr>
              <a:noFill/>
              <a:ln w="9525" cap="sq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dose!$O$28:$R$28</c:f>
              <c:numCache>
                <c:formatCode>General</c:formatCode>
                <c:ptCount val="4"/>
                <c:pt idx="0">
                  <c:v>3.125</c:v>
                </c:pt>
                <c:pt idx="1">
                  <c:v>7.5</c:v>
                </c:pt>
                <c:pt idx="2">
                  <c:v>8.8125000000000018</c:v>
                </c:pt>
                <c:pt idx="3">
                  <c:v>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D0-42B1-882B-580A7135DCC5}"/>
            </c:ext>
          </c:extLst>
        </c:ser>
        <c:dLbls/>
        <c:gapWidth val="50"/>
        <c:overlap val="-27"/>
        <c:axId val="113633920"/>
        <c:axId val="113648000"/>
      </c:barChart>
      <c:catAx>
        <c:axId val="113633920"/>
        <c:scaling>
          <c:orientation val="minMax"/>
        </c:scaling>
        <c:axPos val="b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648000"/>
        <c:crosses val="autoZero"/>
        <c:auto val="1"/>
        <c:lblAlgn val="ctr"/>
        <c:lblOffset val="100"/>
      </c:catAx>
      <c:valAx>
        <c:axId val="113648000"/>
        <c:scaling>
          <c:orientation val="minMax"/>
          <c:max val="2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grated</a:t>
                </a: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 number </a:t>
                </a:r>
              </a:p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0</a:t>
                </a:r>
                <a:r>
                  <a:rPr lang="en-US" altLang="ko-KR" sz="1400" baseline="300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)</a:t>
                </a:r>
                <a:endParaRPr lang="ko-KR" alt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63392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12700"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38854082835909987"/>
          <c:y val="0.20975473667308925"/>
          <c:w val="0.58546982004661241"/>
          <c:h val="0.69747149967886979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time!$B$36:$E$36</c:f>
                <c:numCache>
                  <c:formatCode>General</c:formatCode>
                  <c:ptCount val="4"/>
                  <c:pt idx="0">
                    <c:v>0.17677669529663689</c:v>
                  </c:pt>
                  <c:pt idx="1">
                    <c:v>0.2651650429449553</c:v>
                  </c:pt>
                  <c:pt idx="2">
                    <c:v>0.17677669529663689</c:v>
                  </c:pt>
                  <c:pt idx="3">
                    <c:v>0.35355339059327384</c:v>
                  </c:pt>
                </c:numCache>
              </c:numRef>
            </c:plus>
            <c:minus>
              <c:numRef>
                <c:f>time!$B$36:$E$36</c:f>
                <c:numCache>
                  <c:formatCode>General</c:formatCode>
                  <c:ptCount val="4"/>
                  <c:pt idx="0">
                    <c:v>0.17677669529663689</c:v>
                  </c:pt>
                  <c:pt idx="1">
                    <c:v>0.2651650429449553</c:v>
                  </c:pt>
                  <c:pt idx="2">
                    <c:v>0.17677669529663689</c:v>
                  </c:pt>
                  <c:pt idx="3">
                    <c:v>0.35355339059327384</c:v>
                  </c:pt>
                </c:numCache>
              </c:numRef>
            </c:minus>
            <c:spPr>
              <a:noFill/>
              <a:ln w="9525" cap="sq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time!$B$35:$E$35</c:f>
              <c:numCache>
                <c:formatCode>General</c:formatCode>
                <c:ptCount val="4"/>
                <c:pt idx="0">
                  <c:v>3.25</c:v>
                </c:pt>
                <c:pt idx="1">
                  <c:v>5.6874999999999991</c:v>
                </c:pt>
                <c:pt idx="2">
                  <c:v>13.25</c:v>
                </c:pt>
                <c:pt idx="3">
                  <c:v>16.1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258-4495-8A78-156391330456}"/>
            </c:ext>
          </c:extLst>
        </c:ser>
        <c:dLbls/>
        <c:gapWidth val="50"/>
        <c:overlap val="-27"/>
        <c:axId val="113685632"/>
        <c:axId val="113687168"/>
      </c:barChart>
      <c:catAx>
        <c:axId val="113685632"/>
        <c:scaling>
          <c:orientation val="minMax"/>
        </c:scaling>
        <c:axPos val="b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687168"/>
        <c:crosses val="autoZero"/>
        <c:auto val="1"/>
        <c:lblAlgn val="ctr"/>
        <c:lblOffset val="100"/>
      </c:catAx>
      <c:valAx>
        <c:axId val="113687168"/>
        <c:scaling>
          <c:orientation val="minMax"/>
          <c:max val="2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grated</a:t>
                </a: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 number</a:t>
                </a:r>
              </a:p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10</a:t>
                </a:r>
                <a:r>
                  <a:rPr lang="en-US" altLang="ko-KR" sz="1400" baseline="300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ko-KR" sz="14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)</a:t>
                </a:r>
                <a:endParaRPr lang="ko-KR" alt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954872348076232E-2"/>
              <c:y val="0.21003291586384071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68563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15018066491688536"/>
          <c:y val="5.1597039953339183E-2"/>
          <c:w val="0.82635673665791776"/>
          <c:h val="0.8410035724701080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dPt>
            <c:idx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CD6-4327-A75B-B3650E6CE9CC}"/>
              </c:ext>
            </c:extLst>
          </c:dPt>
          <c:dPt>
            <c:idx val="1"/>
            <c:spPr>
              <a:pattFill prst="pct9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CD6-4327-A75B-B3650E6CE9CC}"/>
              </c:ext>
            </c:extLst>
          </c:dPt>
          <c:dPt>
            <c:idx val="2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CD6-4327-A75B-B3650E6CE9CC}"/>
              </c:ext>
            </c:extLst>
          </c:dPt>
          <c:dPt>
            <c:idx val="3"/>
            <c:spPr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ACD6-4327-A75B-B3650E6CE9CC}"/>
              </c:ext>
            </c:extLst>
          </c:dPt>
          <c:dPt>
            <c:idx val="4"/>
            <c:spPr>
              <a:pattFill prst="nar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ACD6-4327-A75B-B3650E6CE9CC}"/>
              </c:ext>
            </c:extLst>
          </c:dPt>
          <c:dPt>
            <c:idx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ACD6-4327-A75B-B3650E6CE9CC}"/>
              </c:ext>
            </c:extLst>
          </c:dPt>
          <c:errBars>
            <c:errBarType val="plus"/>
            <c:errValType val="cust"/>
            <c:plus>
              <c:numRef>
                <c:f>Sheet1!$N$13:$N$18</c:f>
                <c:numCache>
                  <c:formatCode>General</c:formatCode>
                  <c:ptCount val="6"/>
                  <c:pt idx="0">
                    <c:v>0.18838836953957044</c:v>
                  </c:pt>
                  <c:pt idx="1">
                    <c:v>0.10073639968860419</c:v>
                  </c:pt>
                  <c:pt idx="2">
                    <c:v>3.8870725917241805E-2</c:v>
                  </c:pt>
                  <c:pt idx="3">
                    <c:v>4.6811204736568024E-2</c:v>
                  </c:pt>
                  <c:pt idx="4">
                    <c:v>1.3401492454200773E-2</c:v>
                  </c:pt>
                  <c:pt idx="5">
                    <c:v>9.043720964784837E-3</c:v>
                  </c:pt>
                </c:numCache>
              </c:numRef>
            </c:plus>
            <c:minus>
              <c:numRef>
                <c:f>Sheet1!$N$13:$N$18</c:f>
                <c:numCache>
                  <c:formatCode>General</c:formatCode>
                  <c:ptCount val="6"/>
                  <c:pt idx="0">
                    <c:v>0.18838836953957044</c:v>
                  </c:pt>
                  <c:pt idx="1">
                    <c:v>0.10073639968860419</c:v>
                  </c:pt>
                  <c:pt idx="2">
                    <c:v>3.8870725917241805E-2</c:v>
                  </c:pt>
                  <c:pt idx="3">
                    <c:v>4.6811204736568024E-2</c:v>
                  </c:pt>
                  <c:pt idx="4">
                    <c:v>1.3401492454200773E-2</c:v>
                  </c:pt>
                  <c:pt idx="5">
                    <c:v>9.043720964784837E-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1!$M$13:$M$18</c:f>
              <c:numCache>
                <c:formatCode>General</c:formatCode>
                <c:ptCount val="6"/>
                <c:pt idx="0">
                  <c:v>0.4032</c:v>
                </c:pt>
                <c:pt idx="1">
                  <c:v>0.2016</c:v>
                </c:pt>
                <c:pt idx="2">
                  <c:v>4.3600000000000007E-2</c:v>
                </c:pt>
                <c:pt idx="3">
                  <c:v>4.5200000000000004E-2</c:v>
                </c:pt>
                <c:pt idx="4">
                  <c:v>2.3599999999999996E-2</c:v>
                </c:pt>
                <c:pt idx="5">
                  <c:v>1.5700000000000006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ACD6-4327-A75B-B3650E6CE9CC}"/>
            </c:ext>
          </c:extLst>
        </c:ser>
        <c:dLbls/>
        <c:gapWidth val="70"/>
        <c:overlap val="-27"/>
        <c:axId val="117531392"/>
        <c:axId val="117532928"/>
      </c:barChart>
      <c:catAx>
        <c:axId val="117531392"/>
        <c:scaling>
          <c:orientation val="minMax"/>
        </c:scaling>
        <c:axPos val="b"/>
        <c:maj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7532928"/>
        <c:crosses val="autoZero"/>
        <c:auto val="1"/>
        <c:lblAlgn val="ctr"/>
        <c:lblOffset val="100"/>
      </c:catAx>
      <c:valAx>
        <c:axId val="117532928"/>
        <c:scaling>
          <c:orientation val="minMax"/>
          <c:max val="0.70000000000000018"/>
          <c:min val="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</a:t>
                </a:r>
                <a:r>
                  <a:rPr lang="en-US" altLang="ko-KR" sz="16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weights (g)</a:t>
                </a:r>
                <a:endParaRPr lang="ko-KR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3903313474687421E-3"/>
              <c:y val="0.21283326733872412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75313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92487545718820485"/>
          <c:y val="3.4558180227471809E-4"/>
          <c:w val="7.4008963750200121E-2"/>
          <c:h val="0.7386451224846897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32499" cy="344489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63262" y="1"/>
            <a:ext cx="4332499" cy="344489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r">
              <a:defRPr sz="1300"/>
            </a:lvl1pPr>
          </a:lstStyle>
          <a:p>
            <a:fld id="{57755DA2-71C7-4118-9EAC-C9FC2DBDEDA0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6521450"/>
            <a:ext cx="4332499" cy="344488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63262" y="6521450"/>
            <a:ext cx="4332499" cy="344488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r">
              <a:defRPr sz="1300"/>
            </a:lvl1pPr>
          </a:lstStyle>
          <a:p>
            <a:fld id="{EA09DEEA-3CD8-42E1-B2BF-989B82973E9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8546327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299416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04224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203075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791877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27889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612826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539111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348006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48626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698301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64811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B4016-32A0-412B-8D69-BAC004F14863}" type="datetimeFigureOut">
              <a:rPr lang="ko-KR" altLang="en-US" smtClean="0"/>
              <a:pPr/>
              <a:t>2018-1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7BE23-BB88-4452-9F4F-312A811029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940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7.png"/><Relationship Id="rId18" Type="http://schemas.microsoft.com/office/2007/relationships/hdphoto" Target="../media/hdphoto7.wdp"/><Relationship Id="rId26" Type="http://schemas.microsoft.com/office/2007/relationships/hdphoto" Target="../media/hdphoto11.wdp"/><Relationship Id="rId3" Type="http://schemas.openxmlformats.org/officeDocument/2006/relationships/image" Target="../media/image13.png"/><Relationship Id="rId21" Type="http://schemas.openxmlformats.org/officeDocument/2006/relationships/image" Target="../media/image21.png"/><Relationship Id="rId7" Type="http://schemas.openxmlformats.org/officeDocument/2006/relationships/image" Target="../media/image15.png"/><Relationship Id="rId12" Type="http://schemas.microsoft.com/office/2007/relationships/hdphoto" Target="../media/hdphoto4.wdp"/><Relationship Id="rId17" Type="http://schemas.openxmlformats.org/officeDocument/2006/relationships/image" Target="../media/image19.png"/><Relationship Id="rId25" Type="http://schemas.openxmlformats.org/officeDocument/2006/relationships/image" Target="../media/image23.png"/><Relationship Id="rId2" Type="http://schemas.openxmlformats.org/officeDocument/2006/relationships/image" Target="../media/image12.png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16.png"/><Relationship Id="rId24" Type="http://schemas.microsoft.com/office/2007/relationships/hdphoto" Target="../media/hdphoto10.wdp"/><Relationship Id="rId5" Type="http://schemas.openxmlformats.org/officeDocument/2006/relationships/image" Target="../media/image14.png"/><Relationship Id="rId15" Type="http://schemas.openxmlformats.org/officeDocument/2006/relationships/image" Target="../media/image18.png"/><Relationship Id="rId23" Type="http://schemas.openxmlformats.org/officeDocument/2006/relationships/image" Target="../media/image22.png"/><Relationship Id="rId28" Type="http://schemas.openxmlformats.org/officeDocument/2006/relationships/chart" Target="../charts/chart4.xml"/><Relationship Id="rId10" Type="http://schemas.openxmlformats.org/officeDocument/2006/relationships/chart" Target="../charts/chart2.xml"/><Relationship Id="rId19" Type="http://schemas.openxmlformats.org/officeDocument/2006/relationships/image" Target="../media/image20.png"/><Relationship Id="rId4" Type="http://schemas.microsoft.com/office/2007/relationships/hdphoto" Target="../media/hdphoto1.wdp"/><Relationship Id="rId9" Type="http://schemas.openxmlformats.org/officeDocument/2006/relationships/chart" Target="../charts/chart1.xml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microsoft.com/office/2007/relationships/hdphoto" Target="../media/hdphoto14.wdp"/><Relationship Id="rId18" Type="http://schemas.openxmlformats.org/officeDocument/2006/relationships/image" Target="../media/image35.png"/><Relationship Id="rId3" Type="http://schemas.openxmlformats.org/officeDocument/2006/relationships/image" Target="../media/image25.png"/><Relationship Id="rId21" Type="http://schemas.microsoft.com/office/2007/relationships/hdphoto" Target="../media/hdphoto18.wdp"/><Relationship Id="rId7" Type="http://schemas.openxmlformats.org/officeDocument/2006/relationships/image" Target="../media/image29.png"/><Relationship Id="rId12" Type="http://schemas.openxmlformats.org/officeDocument/2006/relationships/image" Target="../media/image32.png"/><Relationship Id="rId17" Type="http://schemas.microsoft.com/office/2007/relationships/hdphoto" Target="../media/hdphoto16.wdp"/><Relationship Id="rId2" Type="http://schemas.openxmlformats.org/officeDocument/2006/relationships/image" Target="../media/image24.png"/><Relationship Id="rId16" Type="http://schemas.openxmlformats.org/officeDocument/2006/relationships/image" Target="../media/image34.png"/><Relationship Id="rId20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microsoft.com/office/2007/relationships/hdphoto" Target="../media/hdphoto13.wdp"/><Relationship Id="rId5" Type="http://schemas.openxmlformats.org/officeDocument/2006/relationships/image" Target="../media/image27.png"/><Relationship Id="rId15" Type="http://schemas.microsoft.com/office/2007/relationships/hdphoto" Target="../media/hdphoto15.wdp"/><Relationship Id="rId10" Type="http://schemas.openxmlformats.org/officeDocument/2006/relationships/image" Target="../media/image31.png"/><Relationship Id="rId19" Type="http://schemas.microsoft.com/office/2007/relationships/hdphoto" Target="../media/hdphoto17.wdp"/><Relationship Id="rId4" Type="http://schemas.openxmlformats.org/officeDocument/2006/relationships/image" Target="../media/image26.png"/><Relationship Id="rId9" Type="http://schemas.microsoft.com/office/2007/relationships/hdphoto" Target="../media/hdphoto12.wdp"/><Relationship Id="rId14" Type="http://schemas.openxmlformats.org/officeDocument/2006/relationships/image" Target="../media/image33.png"/><Relationship Id="rId22" Type="http://schemas.openxmlformats.org/officeDocument/2006/relationships/image" Target="../media/image3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 preferRelativeResize="0"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694545" y="4216676"/>
            <a:ext cx="2721600" cy="2214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 cstate="print"/>
          <a:srcRect t="2328"/>
          <a:stretch/>
        </p:blipFill>
        <p:spPr>
          <a:xfrm>
            <a:off x="3122982" y="4250510"/>
            <a:ext cx="2579233" cy="2190159"/>
          </a:xfrm>
          <a:prstGeom prst="rect">
            <a:avLst/>
          </a:prstGeom>
        </p:spPr>
      </p:pic>
      <p:cxnSp>
        <p:nvCxnSpPr>
          <p:cNvPr id="5" name="직선 화살표 연결선 4"/>
          <p:cNvCxnSpPr/>
          <p:nvPr/>
        </p:nvCxnSpPr>
        <p:spPr>
          <a:xfrm flipH="1" flipV="1">
            <a:off x="2992627" y="4612538"/>
            <a:ext cx="0" cy="1944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/>
          <p:cNvCxnSpPr/>
          <p:nvPr/>
        </p:nvCxnSpPr>
        <p:spPr>
          <a:xfrm rot="5400000" flipH="1" flipV="1">
            <a:off x="3952767" y="5589718"/>
            <a:ext cx="0" cy="1944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979867" y="6418485"/>
            <a:ext cx="11472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D11b-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021504" y="5104660"/>
            <a:ext cx="13227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 Number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7508" y="3934140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L-60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80549" y="3934140"/>
            <a:ext cx="21932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HL-60 (1.3% DMSO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8572117" y="4328128"/>
            <a:ext cx="199506" cy="23275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6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/>
          <p:cNvSpPr/>
          <p:nvPr/>
        </p:nvSpPr>
        <p:spPr>
          <a:xfrm>
            <a:off x="8572117" y="4841520"/>
            <a:ext cx="199506" cy="232756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8873713" y="4272694"/>
            <a:ext cx="12426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ko-K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873713" y="4788621"/>
            <a:ext cx="11360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D11b 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96550" y="367694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96550" y="506403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30" name="그림 29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852181" y="688152"/>
            <a:ext cx="3741178" cy="2604673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 rot="16200000">
            <a:off x="1992622" y="1773760"/>
            <a:ext cx="1463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ell Number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294591" y="3228177"/>
            <a:ext cx="14076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4/80-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6662961" y="1807294"/>
            <a:ext cx="199506" cy="232756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95000"/>
                <a:lumOff val="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직사각형 33"/>
          <p:cNvSpPr/>
          <p:nvPr/>
        </p:nvSpPr>
        <p:spPr>
          <a:xfrm>
            <a:off x="6662961" y="1352946"/>
            <a:ext cx="199506" cy="232756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TextBox 34"/>
          <p:cNvSpPr txBox="1"/>
          <p:nvPr/>
        </p:nvSpPr>
        <p:spPr>
          <a:xfrm>
            <a:off x="6964557" y="1751860"/>
            <a:ext cx="10390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4/80 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964557" y="1300047"/>
            <a:ext cx="12426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o Staining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1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11329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그룹 52"/>
          <p:cNvGrpSpPr/>
          <p:nvPr/>
        </p:nvGrpSpPr>
        <p:grpSpPr>
          <a:xfrm>
            <a:off x="1074582" y="1079247"/>
            <a:ext cx="4157267" cy="2201917"/>
            <a:chOff x="815274" y="1226902"/>
            <a:chExt cx="4157267" cy="2201917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2" cstate="print"/>
            <a:srcRect l="13583" t="2007"/>
            <a:stretch/>
          </p:blipFill>
          <p:spPr>
            <a:xfrm>
              <a:off x="1452655" y="1400792"/>
              <a:ext cx="1358382" cy="1956311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066821" y="311836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066821" y="251205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066821" y="191305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66821" y="1296264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pic>
          <p:nvPicPr>
            <p:cNvPr id="8" name="그림 7"/>
            <p:cNvPicPr preferRelativeResize="0">
              <a:picLocks/>
            </p:cNvPicPr>
            <p:nvPr/>
          </p:nvPicPr>
          <p:blipFill rotWithShape="1">
            <a:blip r:embed="rId3" cstate="print"/>
            <a:srcRect l="6989" t="1116" b="1"/>
            <a:stretch/>
          </p:blipFill>
          <p:spPr>
            <a:xfrm>
              <a:off x="3591760" y="1400792"/>
              <a:ext cx="1380781" cy="1965914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376672" y="312104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76672" y="265031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76672" y="219707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2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76672" y="175815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376672" y="129742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4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-116231" y="2158407"/>
              <a:ext cx="21707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/</a:t>
              </a:r>
              <a:r>
                <a:rPr lang="el-GR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L)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2146804" y="2050685"/>
              <a:ext cx="192232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</a:p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er mL lavage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54" name="그룹 53"/>
          <p:cNvGrpSpPr/>
          <p:nvPr/>
        </p:nvGrpSpPr>
        <p:grpSpPr>
          <a:xfrm>
            <a:off x="1074581" y="3972577"/>
            <a:ext cx="4176369" cy="2170787"/>
            <a:chOff x="815274" y="4654656"/>
            <a:chExt cx="4176369" cy="2170787"/>
          </a:xfrm>
        </p:grpSpPr>
        <p:pic>
          <p:nvPicPr>
            <p:cNvPr id="15" name="그림 14"/>
            <p:cNvPicPr preferRelativeResize="0">
              <a:picLocks/>
            </p:cNvPicPr>
            <p:nvPr/>
          </p:nvPicPr>
          <p:blipFill rotWithShape="1">
            <a:blip r:embed="rId4" cstate="print"/>
            <a:srcRect l="13901" t="2108"/>
            <a:stretch/>
          </p:blipFill>
          <p:spPr>
            <a:xfrm>
              <a:off x="1435596" y="4803574"/>
              <a:ext cx="1357200" cy="19548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1030643" y="6489659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30643" y="604891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30643" y="561480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30643" y="516223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30643" y="471514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2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pic>
          <p:nvPicPr>
            <p:cNvPr id="22" name="그림 21"/>
            <p:cNvPicPr preferRelativeResize="0">
              <a:picLocks/>
            </p:cNvPicPr>
            <p:nvPr/>
          </p:nvPicPr>
          <p:blipFill rotWithShape="1">
            <a:blip r:embed="rId5" cstate="print"/>
            <a:srcRect l="14387" t="1369"/>
            <a:stretch/>
          </p:blipFill>
          <p:spPr>
            <a:xfrm>
              <a:off x="3634443" y="4788004"/>
              <a:ext cx="1357200" cy="1954800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3429446" y="650807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315634" y="5908584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01820" y="5296608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0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201820" y="4693469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5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-116231" y="5586161"/>
              <a:ext cx="21707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/</a:t>
              </a:r>
              <a:r>
                <a:rPr lang="el-GR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L)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2124920" y="5376080"/>
              <a:ext cx="192232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</a:p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er mL lavage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52" name="그룹 51"/>
          <p:cNvGrpSpPr/>
          <p:nvPr/>
        </p:nvGrpSpPr>
        <p:grpSpPr>
          <a:xfrm>
            <a:off x="6740364" y="1079247"/>
            <a:ext cx="4083563" cy="2170787"/>
            <a:chOff x="7294874" y="1165273"/>
            <a:chExt cx="4083563" cy="2170787"/>
          </a:xfrm>
        </p:grpSpPr>
        <p:pic>
          <p:nvPicPr>
            <p:cNvPr id="28" name="그림 27"/>
            <p:cNvPicPr preferRelativeResize="0">
              <a:picLocks/>
            </p:cNvPicPr>
            <p:nvPr/>
          </p:nvPicPr>
          <p:blipFill rotWithShape="1">
            <a:blip r:embed="rId6" cstate="print"/>
            <a:srcRect l="13708" t="1602"/>
            <a:stretch/>
          </p:blipFill>
          <p:spPr>
            <a:xfrm>
              <a:off x="7887607" y="1317001"/>
              <a:ext cx="1357200" cy="195480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7539094" y="302681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539094" y="2427324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539094" y="181467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.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539094" y="1218362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.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pic>
          <p:nvPicPr>
            <p:cNvPr id="34" name="그림 33"/>
            <p:cNvPicPr preferRelativeResize="0">
              <a:picLocks/>
            </p:cNvPicPr>
            <p:nvPr/>
          </p:nvPicPr>
          <p:blipFill rotWithShape="1">
            <a:blip r:embed="rId7" cstate="print"/>
            <a:srcRect l="7449" t="2365"/>
            <a:stretch/>
          </p:blipFill>
          <p:spPr>
            <a:xfrm>
              <a:off x="10021237" y="1295062"/>
              <a:ext cx="1357200" cy="19548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9781199" y="3021998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0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9781199" y="265687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1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9781199" y="228808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2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9781199" y="193362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9781199" y="157916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4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9781199" y="121172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6363369" y="2096778"/>
              <a:ext cx="21707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3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/</a:t>
              </a:r>
              <a:r>
                <a:rPr lang="el-GR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L)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8619581" y="1954936"/>
              <a:ext cx="192232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eutrophil count (10</a:t>
              </a:r>
              <a:r>
                <a:rPr lang="en-US" altLang="ko-KR" sz="1400" baseline="300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5</a:t>
              </a:r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)</a:t>
              </a:r>
            </a:p>
            <a:p>
              <a:pPr algn="ctr"/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er mL lavage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2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866689" y="3201031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380755" y="3201031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LAG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018489" y="3203303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532555" y="3203303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LAG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843940" y="6051148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405774" y="6051148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REP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043509" y="6051148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605343" y="6051148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REP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477457" y="3160083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8039291" y="3160083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A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9622434" y="3160083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0184268" y="3160083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AC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20984" y="563147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716432" y="3595238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6348201" y="563147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057986" y="800227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lood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941305" y="800227"/>
            <a:ext cx="12330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eritoneum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7664206" y="800227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lood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547525" y="800227"/>
            <a:ext cx="12330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eritoneum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060259" y="3784549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lood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943578" y="3784549"/>
            <a:ext cx="12330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eritoneum</a:t>
            </a:r>
            <a:endParaRPr lang="ko-KR" altLang="en-US" sz="1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81" name="그룹 80"/>
          <p:cNvGrpSpPr/>
          <p:nvPr/>
        </p:nvGrpSpPr>
        <p:grpSpPr>
          <a:xfrm>
            <a:off x="2144330" y="1286224"/>
            <a:ext cx="539086" cy="307777"/>
            <a:chOff x="2144330" y="1286224"/>
            <a:chExt cx="539086" cy="307777"/>
          </a:xfrm>
        </p:grpSpPr>
        <p:cxnSp>
          <p:nvCxnSpPr>
            <p:cNvPr id="79" name="직선 연결선 78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2" name="그룹 81"/>
          <p:cNvGrpSpPr/>
          <p:nvPr/>
        </p:nvGrpSpPr>
        <p:grpSpPr>
          <a:xfrm>
            <a:off x="4268836" y="1083781"/>
            <a:ext cx="539086" cy="307777"/>
            <a:chOff x="2144330" y="1286224"/>
            <a:chExt cx="539086" cy="307777"/>
          </a:xfrm>
        </p:grpSpPr>
        <p:cxnSp>
          <p:nvCxnSpPr>
            <p:cNvPr id="83" name="직선 연결선 82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5" name="그룹 84"/>
          <p:cNvGrpSpPr/>
          <p:nvPr/>
        </p:nvGrpSpPr>
        <p:grpSpPr>
          <a:xfrm>
            <a:off x="4318876" y="4341053"/>
            <a:ext cx="539086" cy="307777"/>
            <a:chOff x="2144330" y="1286224"/>
            <a:chExt cx="539086" cy="307777"/>
          </a:xfrm>
        </p:grpSpPr>
        <p:cxnSp>
          <p:nvCxnSpPr>
            <p:cNvPr id="86" name="직선 연결선 85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8" name="그룹 87"/>
          <p:cNvGrpSpPr/>
          <p:nvPr/>
        </p:nvGrpSpPr>
        <p:grpSpPr>
          <a:xfrm>
            <a:off x="2130682" y="4138609"/>
            <a:ext cx="539086" cy="307777"/>
            <a:chOff x="2144330" y="1286224"/>
            <a:chExt cx="539086" cy="307777"/>
          </a:xfrm>
        </p:grpSpPr>
        <p:cxnSp>
          <p:nvCxnSpPr>
            <p:cNvPr id="89" name="직선 연결선 88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91" name="그룹 90"/>
          <p:cNvGrpSpPr/>
          <p:nvPr/>
        </p:nvGrpSpPr>
        <p:grpSpPr>
          <a:xfrm>
            <a:off x="7761924" y="1293044"/>
            <a:ext cx="539086" cy="307777"/>
            <a:chOff x="2144330" y="1286224"/>
            <a:chExt cx="539086" cy="307777"/>
          </a:xfrm>
        </p:grpSpPr>
        <p:cxnSp>
          <p:nvCxnSpPr>
            <p:cNvPr id="92" name="직선 연결선 91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94" name="그룹 93"/>
          <p:cNvGrpSpPr/>
          <p:nvPr/>
        </p:nvGrpSpPr>
        <p:grpSpPr>
          <a:xfrm>
            <a:off x="9865958" y="1527331"/>
            <a:ext cx="539086" cy="307777"/>
            <a:chOff x="2144330" y="1286224"/>
            <a:chExt cx="539086" cy="307777"/>
          </a:xfrm>
        </p:grpSpPr>
        <p:cxnSp>
          <p:nvCxnSpPr>
            <p:cNvPr id="95" name="직선 연결선 94"/>
            <p:cNvCxnSpPr/>
            <p:nvPr/>
          </p:nvCxnSpPr>
          <p:spPr>
            <a:xfrm>
              <a:off x="2144330" y="1586889"/>
              <a:ext cx="5390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>
              <a:off x="2245300" y="1286224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s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1161227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154676" y="3161192"/>
            <a:ext cx="2014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561677" y="3163601"/>
            <a:ext cx="2014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063030943"/>
              </p:ext>
            </p:extLst>
          </p:nvPr>
        </p:nvGraphicFramePr>
        <p:xfrm>
          <a:off x="6452804" y="3358282"/>
          <a:ext cx="2392200" cy="2616108"/>
        </p:xfrm>
        <a:graphic>
          <a:graphicData uri="http://schemas.openxmlformats.org/presentationml/2006/ole">
            <p:oleObj spid="_x0000_s1230" name="Prism Project" r:id="rId3" imgW="3420000" imgH="2628000" progId="">
              <p:embed/>
            </p:oleObj>
          </a:graphicData>
        </a:graphic>
      </p:graphicFrame>
      <p:cxnSp>
        <p:nvCxnSpPr>
          <p:cNvPr id="8" name="직선 연결선 7"/>
          <p:cNvCxnSpPr/>
          <p:nvPr/>
        </p:nvCxnSpPr>
        <p:spPr>
          <a:xfrm>
            <a:off x="7901073" y="4046411"/>
            <a:ext cx="569386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9" name="TextBox 8"/>
          <p:cNvSpPr txBox="1"/>
          <p:nvPr/>
        </p:nvSpPr>
        <p:spPr>
          <a:xfrm>
            <a:off x="7942012" y="3877183"/>
            <a:ext cx="487512" cy="2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8016" latinLnBrk="0">
              <a:defRPr/>
            </a:pPr>
            <a:r>
              <a:rPr lang="en-US" altLang="ko-KR" sz="1294" b="1" kern="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***</a:t>
            </a:r>
            <a:endParaRPr lang="ko-KR" altLang="en-US" sz="1294" b="1" kern="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657254" y="5704390"/>
            <a:ext cx="10444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C regimen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7759306" y="5701156"/>
            <a:ext cx="8460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개체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538598203"/>
              </p:ext>
            </p:extLst>
          </p:nvPr>
        </p:nvGraphicFramePr>
        <p:xfrm>
          <a:off x="2875697" y="3357801"/>
          <a:ext cx="2391421" cy="2616587"/>
        </p:xfrm>
        <a:graphic>
          <a:graphicData uri="http://schemas.openxmlformats.org/presentationml/2006/ole">
            <p:oleObj spid="_x0000_s1231" name="Prism Project" r:id="rId4" imgW="3420000" imgH="2628000" progId="">
              <p:embed/>
            </p:oleObj>
          </a:graphicData>
        </a:graphic>
      </p:graphicFrame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28230978"/>
              </p:ext>
            </p:extLst>
          </p:nvPr>
        </p:nvGraphicFramePr>
        <p:xfrm>
          <a:off x="6358893" y="5460812"/>
          <a:ext cx="2424722" cy="243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2199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33304"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LAG</a:t>
                      </a:r>
                      <a:endParaRPr lang="ko-KR" altLang="en-US" sz="11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6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6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0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+</a:t>
                      </a:r>
                      <a:endParaRPr lang="ko-KR" altLang="en-US" sz="1600" b="0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cxnSp>
        <p:nvCxnSpPr>
          <p:cNvPr id="29" name="직선 연결선 28"/>
          <p:cNvCxnSpPr/>
          <p:nvPr/>
        </p:nvCxnSpPr>
        <p:spPr>
          <a:xfrm>
            <a:off x="7198086" y="3739493"/>
            <a:ext cx="569386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30" name="TextBox 29"/>
          <p:cNvSpPr txBox="1"/>
          <p:nvPr/>
        </p:nvSpPr>
        <p:spPr>
          <a:xfrm>
            <a:off x="7239025" y="3570266"/>
            <a:ext cx="487512" cy="2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8016" latinLnBrk="0">
              <a:defRPr/>
            </a:pPr>
            <a:r>
              <a:rPr lang="en-US" altLang="ko-KR" sz="1294" b="1" kern="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***</a:t>
            </a:r>
            <a:endParaRPr lang="ko-KR" altLang="en-US" sz="1294" b="1" kern="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191382" y="5704390"/>
            <a:ext cx="8048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5-FU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33" name="직선 연결선 32"/>
          <p:cNvCxnSpPr/>
          <p:nvPr/>
        </p:nvCxnSpPr>
        <p:spPr>
          <a:xfrm>
            <a:off x="4170755" y="5701156"/>
            <a:ext cx="8460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4" name="표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4086969"/>
              </p:ext>
            </p:extLst>
          </p:nvPr>
        </p:nvGraphicFramePr>
        <p:xfrm>
          <a:off x="2770342" y="5447878"/>
          <a:ext cx="2424722" cy="243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2199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3424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33164"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LAG</a:t>
                      </a:r>
                      <a:endParaRPr lang="ko-KR" altLang="en-US" sz="11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6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600" b="1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0" dirty="0" smtClean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+</a:t>
                      </a:r>
                      <a:endParaRPr lang="ko-KR" altLang="en-US" sz="1600" b="0" dirty="0" smtClean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cxnSp>
        <p:nvCxnSpPr>
          <p:cNvPr id="35" name="직선 연결선 34"/>
          <p:cNvCxnSpPr/>
          <p:nvPr/>
        </p:nvCxnSpPr>
        <p:spPr>
          <a:xfrm>
            <a:off x="4308438" y="3943647"/>
            <a:ext cx="569386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36" name="TextBox 35"/>
          <p:cNvSpPr txBox="1"/>
          <p:nvPr/>
        </p:nvSpPr>
        <p:spPr>
          <a:xfrm>
            <a:off x="4349377" y="3774420"/>
            <a:ext cx="487512" cy="2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8016" latinLnBrk="0">
              <a:defRPr/>
            </a:pPr>
            <a:r>
              <a:rPr lang="en-US" altLang="ko-KR" sz="1294" b="1" kern="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***</a:t>
            </a:r>
            <a:endParaRPr lang="ko-KR" altLang="en-US" sz="1294" b="1" kern="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>
            <a:off x="3605451" y="3636730"/>
            <a:ext cx="569386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38" name="TextBox 37"/>
          <p:cNvSpPr txBox="1"/>
          <p:nvPr/>
        </p:nvSpPr>
        <p:spPr>
          <a:xfrm>
            <a:off x="3646390" y="3467503"/>
            <a:ext cx="487512" cy="2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8016" latinLnBrk="0">
              <a:defRPr/>
            </a:pPr>
            <a:r>
              <a:rPr lang="en-US" altLang="ko-KR" sz="1294" b="1" kern="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***</a:t>
            </a:r>
            <a:endParaRPr lang="ko-KR" altLang="en-US" sz="1294" b="1" kern="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9" name="직사각형 38"/>
          <p:cNvSpPr/>
          <p:nvPr/>
        </p:nvSpPr>
        <p:spPr>
          <a:xfrm rot="16200000">
            <a:off x="1919225" y="4252282"/>
            <a:ext cx="192713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60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lood neutrophil count </a:t>
            </a:r>
          </a:p>
          <a:p>
            <a:pPr algn="ctr">
              <a:defRPr sz="60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10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3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cells/</a:t>
            </a:r>
            <a:r>
              <a:rPr lang="el-GR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)</a:t>
            </a:r>
            <a:endParaRPr lang="ko-KR" altLang="ko-KR" sz="1200" dirty="0">
              <a:solidFill>
                <a:prstClr val="black"/>
              </a:solidFill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4047862" y="1896622"/>
            <a:ext cx="345229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909432859"/>
              </p:ext>
            </p:extLst>
          </p:nvPr>
        </p:nvGraphicFramePr>
        <p:xfrm>
          <a:off x="4047864" y="1599957"/>
          <a:ext cx="3027626" cy="259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2518">
                  <a:extLst>
                    <a:ext uri="{9D8B030D-6E8A-4147-A177-3AD203B41FA5}">
                      <a16:colId xmlns:a16="http://schemas.microsoft.com/office/drawing/2014/main" xmlns="" val="2705274889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693386853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987122858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2914699836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3717168567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2690970842"/>
                    </a:ext>
                  </a:extLst>
                </a:gridCol>
                <a:gridCol w="432518">
                  <a:extLst>
                    <a:ext uri="{9D8B030D-6E8A-4147-A177-3AD203B41FA5}">
                      <a16:colId xmlns:a16="http://schemas.microsoft.com/office/drawing/2014/main" xmlns="" val="1104249470"/>
                    </a:ext>
                  </a:extLst>
                </a:gridCol>
              </a:tblGrid>
              <a:tr h="24064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16563893"/>
                  </a:ext>
                </a:extLst>
              </a:tr>
            </a:tbl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7135957" y="1599957"/>
            <a:ext cx="3642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아래쪽 화살표 18"/>
          <p:cNvSpPr/>
          <p:nvPr/>
        </p:nvSpPr>
        <p:spPr>
          <a:xfrm flipV="1">
            <a:off x="4125459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아래쪽 화살표 61"/>
          <p:cNvSpPr/>
          <p:nvPr/>
        </p:nvSpPr>
        <p:spPr>
          <a:xfrm flipV="1">
            <a:off x="4545975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아래쪽 화살표 62"/>
          <p:cNvSpPr/>
          <p:nvPr/>
        </p:nvSpPr>
        <p:spPr>
          <a:xfrm flipV="1">
            <a:off x="4966491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아래쪽 화살표 63"/>
          <p:cNvSpPr/>
          <p:nvPr/>
        </p:nvSpPr>
        <p:spPr>
          <a:xfrm flipV="1">
            <a:off x="5387007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아래쪽 화살표 64"/>
          <p:cNvSpPr/>
          <p:nvPr/>
        </p:nvSpPr>
        <p:spPr>
          <a:xfrm flipV="1">
            <a:off x="5807523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아래쪽 화살표 65"/>
          <p:cNvSpPr/>
          <p:nvPr/>
        </p:nvSpPr>
        <p:spPr>
          <a:xfrm flipV="1">
            <a:off x="6228039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아래쪽 화살표 66"/>
          <p:cNvSpPr/>
          <p:nvPr/>
        </p:nvSpPr>
        <p:spPr>
          <a:xfrm flipV="1">
            <a:off x="6648557" y="1947829"/>
            <a:ext cx="149289" cy="2194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직사각형 67"/>
          <p:cNvSpPr/>
          <p:nvPr/>
        </p:nvSpPr>
        <p:spPr>
          <a:xfrm rot="16200000">
            <a:off x="5399472" y="4246100"/>
            <a:ext cx="192713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60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lood neutrophil count </a:t>
            </a:r>
          </a:p>
          <a:p>
            <a:pPr algn="ctr">
              <a:defRPr sz="60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10</a:t>
            </a:r>
            <a:r>
              <a:rPr lang="en-US" altLang="ko-KR" sz="1200" baseline="300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3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cells/</a:t>
            </a:r>
            <a:r>
              <a:rPr lang="el-GR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μ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)</a:t>
            </a:r>
            <a:endParaRPr lang="ko-KR" altLang="ko-KR" sz="1200" dirty="0">
              <a:solidFill>
                <a:prstClr val="black"/>
              </a:solidFill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269626" y="980087"/>
            <a:ext cx="2353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-FU (A) or AC regimen (B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직선 화살표 연결선 68"/>
          <p:cNvCxnSpPr/>
          <p:nvPr/>
        </p:nvCxnSpPr>
        <p:spPr>
          <a:xfrm>
            <a:off x="4214481" y="1334939"/>
            <a:ext cx="0" cy="288000"/>
          </a:xfrm>
          <a:prstGeom prst="straightConnector1">
            <a:avLst/>
          </a:prstGeom>
          <a:ln w="19050" cap="sq">
            <a:solidFill>
              <a:schemeClr val="tx1"/>
            </a:solidFill>
            <a:prstDash val="sysDot"/>
            <a:headEnd type="oval" w="med" len="med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화살표 연결선 69"/>
          <p:cNvCxnSpPr/>
          <p:nvPr/>
        </p:nvCxnSpPr>
        <p:spPr>
          <a:xfrm>
            <a:off x="6760522" y="1334939"/>
            <a:ext cx="0" cy="288000"/>
          </a:xfrm>
          <a:prstGeom prst="straightConnector1">
            <a:avLst/>
          </a:prstGeom>
          <a:ln w="19050" cap="sq">
            <a:solidFill>
              <a:schemeClr val="tx1"/>
            </a:solidFill>
            <a:prstDash val="sysDot"/>
            <a:headEnd type="oval" w="med" len="med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6000554" y="980087"/>
            <a:ext cx="1888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BC analysis (Blood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오른쪽 중괄호 71"/>
          <p:cNvSpPr/>
          <p:nvPr/>
        </p:nvSpPr>
        <p:spPr>
          <a:xfrm rot="5400000">
            <a:off x="5390646" y="1075009"/>
            <a:ext cx="130630" cy="260912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TextBox 72"/>
          <p:cNvSpPr txBox="1"/>
          <p:nvPr/>
        </p:nvSpPr>
        <p:spPr>
          <a:xfrm>
            <a:off x="4625925" y="2506117"/>
            <a:ext cx="168437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LAG (250mg/kg)</a:t>
            </a:r>
          </a:p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.O. administra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3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249144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6437" t="18193" r="61557" b="73525"/>
          <a:stretch/>
        </p:blipFill>
        <p:spPr>
          <a:xfrm flipV="1">
            <a:off x="611009" y="1979913"/>
            <a:ext cx="2187264" cy="2958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2842536" y="1971033"/>
            <a:ext cx="1142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APDH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42536" y="1283144"/>
            <a:ext cx="1142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XCL2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48486" y="1627089"/>
            <a:ext cx="1142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XCL8</a:t>
            </a:r>
            <a:endParaRPr lang="ko-KR" altLang="en-US" sz="14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2" name="그림 11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 xmlns="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767" t="61289" r="70192" b="31310"/>
          <a:stretch/>
        </p:blipFill>
        <p:spPr>
          <a:xfrm flipV="1">
            <a:off x="619106" y="1634208"/>
            <a:ext cx="2179766" cy="2825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3" name="표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721307839"/>
              </p:ext>
            </p:extLst>
          </p:nvPr>
        </p:nvGraphicFramePr>
        <p:xfrm>
          <a:off x="612418" y="1021365"/>
          <a:ext cx="3116298" cy="27958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435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435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4354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4354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42110">
                  <a:extLst>
                    <a:ext uri="{9D8B030D-6E8A-4147-A177-3AD203B41FA5}">
                      <a16:colId xmlns:a16="http://schemas.microsoft.com/office/drawing/2014/main" xmlns="" val="3095846392"/>
                    </a:ext>
                  </a:extLst>
                </a:gridCol>
              </a:tblGrid>
              <a:tr h="279582"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200" b="0" dirty="0" smtClean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200" b="0" dirty="0" smtClean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1200" b="0" dirty="0" smtClean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10</a:t>
                      </a:r>
                      <a:endParaRPr lang="ko-KR" altLang="en-US" sz="1200" b="0" dirty="0" smtClean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2628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GEM (</a:t>
                      </a:r>
                      <a:r>
                        <a:rPr lang="el-GR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altLang="ko-KR" sz="1200" b="0" dirty="0" smtClean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g/ml)</a:t>
                      </a:r>
                      <a:endParaRPr lang="ko-KR" altLang="en-US" sz="1200" b="0" dirty="0" smtClean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186958" y="47307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12294" y="72475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 xmlns="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7127" t="17420" r="57292" b="15696"/>
          <a:stretch/>
        </p:blipFill>
        <p:spPr>
          <a:xfrm>
            <a:off x="4431689" y="1634208"/>
            <a:ext cx="2509200" cy="29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 xmlns="">
                  <a14:imgLayer r:embed="rId8">
                    <a14:imgEffect>
                      <a14:brightnessContrast bright="-10000" contrast="40000"/>
                    </a14:imgEffect>
                  </a14:imgLayer>
                </a14:imgProps>
              </a:ext>
            </a:extLst>
          </a:blip>
          <a:srcRect l="6615" t="11412" r="57549" b="14741"/>
          <a:stretch/>
        </p:blipFill>
        <p:spPr>
          <a:xfrm>
            <a:off x="4431689" y="1293539"/>
            <a:ext cx="2507432" cy="295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/>
          <p:cNvSpPr txBox="1"/>
          <p:nvPr/>
        </p:nvSpPr>
        <p:spPr>
          <a:xfrm>
            <a:off x="6924635" y="1281013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24635" y="1652141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DP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570297" y="10213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076939" y="10213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571438" y="10213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028078" y="102136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582921" y="10213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934296" y="1021365"/>
            <a:ext cx="7512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891398" y="47307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37" name="차트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703718987"/>
              </p:ext>
            </p:extLst>
          </p:nvPr>
        </p:nvGraphicFramePr>
        <p:xfrm>
          <a:off x="3152788" y="4153432"/>
          <a:ext cx="2224800" cy="2489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186958" y="367906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957915" y="367906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43" name="차트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921999075"/>
              </p:ext>
            </p:extLst>
          </p:nvPr>
        </p:nvGraphicFramePr>
        <p:xfrm>
          <a:off x="328251" y="4153433"/>
          <a:ext cx="2223533" cy="2489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 xmlns="">
                  <a14:imgLayer r:embed="rId12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t="8669" b="12560"/>
          <a:stretch/>
        </p:blipFill>
        <p:spPr>
          <a:xfrm>
            <a:off x="619749" y="1293539"/>
            <a:ext cx="2178523" cy="29678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" name="직선 연결선 5"/>
          <p:cNvCxnSpPr/>
          <p:nvPr/>
        </p:nvCxnSpPr>
        <p:spPr>
          <a:xfrm>
            <a:off x="619106" y="1024919"/>
            <a:ext cx="217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>
            <a:off x="4433457" y="1024919"/>
            <a:ext cx="2509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117914" y="712227"/>
            <a:ext cx="1353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M(10</a:t>
            </a:r>
            <a:r>
              <a:rPr lang="el-GR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그림 51"/>
          <p:cNvPicPr preferRelativeResize="0">
            <a:picLocks/>
          </p:cNvPicPr>
          <p:nvPr/>
        </p:nvPicPr>
        <p:blipFill rotWithShape="1">
          <a:blip r:embed="rId13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086" t="23336" r="24262" b="16058"/>
          <a:stretch/>
        </p:blipFill>
        <p:spPr>
          <a:xfrm>
            <a:off x="8395025" y="3193007"/>
            <a:ext cx="2541600" cy="27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그림 52"/>
          <p:cNvPicPr>
            <a:picLocks noChangeAspect="1"/>
          </p:cNvPicPr>
          <p:nvPr/>
        </p:nvPicPr>
        <p:blipFill rotWithShape="1">
          <a:blip r:embed="rId15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16">
                    <a14:imgEffect>
                      <a14:brightnessContrast bright="10000" contrast="20000"/>
                    </a14:imgEffect>
                  </a14:imgLayer>
                </a14:imgProps>
              </a:ext>
            </a:extLst>
          </a:blip>
          <a:srcRect l="2528" t="11349" r="22843" b="23357"/>
          <a:stretch/>
        </p:blipFill>
        <p:spPr>
          <a:xfrm>
            <a:off x="8395027" y="1624603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그림 53"/>
          <p:cNvPicPr>
            <a:picLocks noChangeAspect="1"/>
          </p:cNvPicPr>
          <p:nvPr/>
        </p:nvPicPr>
        <p:blipFill rotWithShape="1">
          <a:blip r:embed="rId17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18">
                    <a14:imgEffect>
                      <a14:brightnessContrast bright="10000" contrast="40000"/>
                    </a14:imgEffect>
                  </a14:imgLayer>
                </a14:imgProps>
              </a:ext>
            </a:extLst>
          </a:blip>
          <a:srcRect l="24171" t="12001" r="2151" b="24638"/>
          <a:stretch/>
        </p:blipFill>
        <p:spPr>
          <a:xfrm flipH="1">
            <a:off x="8395027" y="1310922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그림 54"/>
          <p:cNvPicPr>
            <a:picLocks noChangeAspect="1"/>
          </p:cNvPicPr>
          <p:nvPr/>
        </p:nvPicPr>
        <p:blipFill rotWithShape="1">
          <a:blip r:embed="rId19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20">
                    <a14:imgEffect>
                      <a14:brightnessContrast bright="10000" contrast="20000"/>
                    </a14:imgEffect>
                  </a14:imgLayer>
                </a14:imgProps>
              </a:ext>
            </a:extLst>
          </a:blip>
          <a:srcRect l="2990" t="14798" r="23685" b="15371"/>
          <a:stretch/>
        </p:blipFill>
        <p:spPr>
          <a:xfrm>
            <a:off x="8395027" y="2251965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그림 55"/>
          <p:cNvPicPr>
            <a:picLocks noChangeAspect="1"/>
          </p:cNvPicPr>
          <p:nvPr/>
        </p:nvPicPr>
        <p:blipFill rotWithShape="1">
          <a:blip r:embed="rId21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22">
                    <a14:imgEffect>
                      <a14:brightnessContrast bright="10000" contrast="40000"/>
                    </a14:imgEffect>
                  </a14:imgLayer>
                </a14:imgProps>
              </a:ext>
            </a:extLst>
          </a:blip>
          <a:srcRect l="24176" t="26535" r="6810" b="43211"/>
          <a:stretch/>
        </p:blipFill>
        <p:spPr>
          <a:xfrm flipH="1">
            <a:off x="8395027" y="1938284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그림 56"/>
          <p:cNvPicPr>
            <a:picLocks noChangeAspect="1"/>
          </p:cNvPicPr>
          <p:nvPr/>
        </p:nvPicPr>
        <p:blipFill rotWithShape="1">
          <a:blip r:embed="rId23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24">
                    <a14:imgEffect>
                      <a14:brightnessContrast bright="10000" contrast="20000"/>
                    </a14:imgEffect>
                  </a14:imgLayer>
                </a14:imgProps>
              </a:ext>
            </a:extLst>
          </a:blip>
          <a:srcRect l="26257" t="24999" r="10794" b="29306"/>
          <a:stretch/>
        </p:blipFill>
        <p:spPr>
          <a:xfrm flipH="1">
            <a:off x="8395027" y="2879327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그림 57"/>
          <p:cNvPicPr>
            <a:picLocks noChangeAspect="1"/>
          </p:cNvPicPr>
          <p:nvPr/>
        </p:nvPicPr>
        <p:blipFill rotWithShape="1">
          <a:blip r:embed="rId25" cstate="print">
            <a:grayscl/>
            <a:extLst>
              <a:ext uri="{BEBA8EAE-BF5A-486C-A8C5-ECC9F3942E4B}">
                <a14:imgProps xmlns:a14="http://schemas.microsoft.com/office/drawing/2010/main" xmlns="">
                  <a14:imgLayer r:embed="rId2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9006" t="24336" r="19494" b="44863"/>
          <a:stretch/>
        </p:blipFill>
        <p:spPr>
          <a:xfrm flipH="1" flipV="1">
            <a:off x="8395026" y="2565646"/>
            <a:ext cx="2542499" cy="271802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9" name="표 5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839981933"/>
              </p:ext>
            </p:extLst>
          </p:nvPr>
        </p:nvGraphicFramePr>
        <p:xfrm>
          <a:off x="8369975" y="1042616"/>
          <a:ext cx="2597973" cy="2486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113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7113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7113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7113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7113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33771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0850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21434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 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5738" marR="65738" marT="32869" marB="32869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60" name="TextBox 59"/>
          <p:cNvSpPr txBox="1"/>
          <p:nvPr/>
        </p:nvSpPr>
        <p:spPr>
          <a:xfrm>
            <a:off x="10967815" y="1306580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967815" y="1927454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0967815" y="161239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0967815" y="223327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0967815" y="288185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967815" y="3180481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0949076" y="1051114"/>
            <a:ext cx="87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0967815" y="2557564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8395027" y="1025540"/>
            <a:ext cx="25416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9098203" y="714712"/>
            <a:ext cx="1394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M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10</a:t>
            </a:r>
            <a:r>
              <a:rPr lang="el-G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7843402" y="470860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88" name="차트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16484345"/>
              </p:ext>
            </p:extLst>
          </p:nvPr>
        </p:nvGraphicFramePr>
        <p:xfrm>
          <a:off x="5924810" y="3903176"/>
          <a:ext cx="2278581" cy="249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89" name="표 8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987562264"/>
              </p:ext>
            </p:extLst>
          </p:nvPr>
        </p:nvGraphicFramePr>
        <p:xfrm>
          <a:off x="6578755" y="6059992"/>
          <a:ext cx="1464488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0767">
                  <a:extLst>
                    <a:ext uri="{9D8B030D-6E8A-4147-A177-3AD203B41FA5}">
                      <a16:colId xmlns:a16="http://schemas.microsoft.com/office/drawing/2014/main" xmlns="" val="2348385497"/>
                    </a:ext>
                  </a:extLst>
                </a:gridCol>
                <a:gridCol w="400293">
                  <a:extLst>
                    <a:ext uri="{9D8B030D-6E8A-4147-A177-3AD203B41FA5}">
                      <a16:colId xmlns:a16="http://schemas.microsoft.com/office/drawing/2014/main" xmlns="" val="1298885529"/>
                    </a:ext>
                  </a:extLst>
                </a:gridCol>
                <a:gridCol w="322187">
                  <a:extLst>
                    <a:ext uri="{9D8B030D-6E8A-4147-A177-3AD203B41FA5}">
                      <a16:colId xmlns:a16="http://schemas.microsoft.com/office/drawing/2014/main" xmlns="" val="2449856346"/>
                    </a:ext>
                  </a:extLst>
                </a:gridCol>
                <a:gridCol w="361241">
                  <a:extLst>
                    <a:ext uri="{9D8B030D-6E8A-4147-A177-3AD203B41FA5}">
                      <a16:colId xmlns:a16="http://schemas.microsoft.com/office/drawing/2014/main" xmlns="" val="83181329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63466984"/>
                  </a:ext>
                </a:extLst>
              </a:tr>
            </a:tbl>
          </a:graphicData>
        </a:graphic>
      </p:graphicFrame>
      <p:sp>
        <p:nvSpPr>
          <p:cNvPr id="90" name="TextBox 89"/>
          <p:cNvSpPr txBox="1"/>
          <p:nvPr/>
        </p:nvSpPr>
        <p:spPr>
          <a:xfrm>
            <a:off x="6788963" y="6244655"/>
            <a:ext cx="1204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M (</a:t>
            </a:r>
            <a:r>
              <a:rPr lang="el-GR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574542" y="367906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92" name="직선 연결선 91"/>
          <p:cNvCxnSpPr/>
          <p:nvPr/>
        </p:nvCxnSpPr>
        <p:spPr>
          <a:xfrm>
            <a:off x="6778148" y="4348162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>
            <a:off x="6778148" y="4575207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>
            <a:off x="6778148" y="4783591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6847313" y="461045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978399" y="4390491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7147206" y="4160987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8677425" y="3679066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99" name="차트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327319272"/>
              </p:ext>
            </p:extLst>
          </p:nvPr>
        </p:nvGraphicFramePr>
        <p:xfrm>
          <a:off x="8965746" y="3770040"/>
          <a:ext cx="2270199" cy="249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100" name="표 9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23021227"/>
              </p:ext>
            </p:extLst>
          </p:nvPr>
        </p:nvGraphicFramePr>
        <p:xfrm>
          <a:off x="9537385" y="6072518"/>
          <a:ext cx="1535949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7041">
                  <a:extLst>
                    <a:ext uri="{9D8B030D-6E8A-4147-A177-3AD203B41FA5}">
                      <a16:colId xmlns:a16="http://schemas.microsoft.com/office/drawing/2014/main" xmlns="" val="2348385497"/>
                    </a:ext>
                  </a:extLst>
                </a:gridCol>
                <a:gridCol w="337294">
                  <a:extLst>
                    <a:ext uri="{9D8B030D-6E8A-4147-A177-3AD203B41FA5}">
                      <a16:colId xmlns:a16="http://schemas.microsoft.com/office/drawing/2014/main" xmlns="" val="1298885529"/>
                    </a:ext>
                  </a:extLst>
                </a:gridCol>
                <a:gridCol w="397745">
                  <a:extLst>
                    <a:ext uri="{9D8B030D-6E8A-4147-A177-3AD203B41FA5}">
                      <a16:colId xmlns:a16="http://schemas.microsoft.com/office/drawing/2014/main" xmlns="" val="2449856346"/>
                    </a:ext>
                  </a:extLst>
                </a:gridCol>
                <a:gridCol w="353869">
                  <a:extLst>
                    <a:ext uri="{9D8B030D-6E8A-4147-A177-3AD203B41FA5}">
                      <a16:colId xmlns:a16="http://schemas.microsoft.com/office/drawing/2014/main" xmlns="" val="83181329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63466984"/>
                  </a:ext>
                </a:extLst>
              </a:tr>
            </a:tbl>
          </a:graphicData>
        </a:graphic>
      </p:graphicFrame>
      <p:sp>
        <p:nvSpPr>
          <p:cNvPr id="101" name="TextBox 100"/>
          <p:cNvSpPr txBox="1"/>
          <p:nvPr/>
        </p:nvSpPr>
        <p:spPr>
          <a:xfrm>
            <a:off x="10006713" y="6282233"/>
            <a:ext cx="843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직선 연결선 101"/>
          <p:cNvCxnSpPr/>
          <p:nvPr/>
        </p:nvCxnSpPr>
        <p:spPr>
          <a:xfrm>
            <a:off x="9945102" y="4355227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연결선 102"/>
          <p:cNvCxnSpPr/>
          <p:nvPr/>
        </p:nvCxnSpPr>
        <p:spPr>
          <a:xfrm>
            <a:off x="9945102" y="4582272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직선 연결선 103"/>
          <p:cNvCxnSpPr/>
          <p:nvPr/>
        </p:nvCxnSpPr>
        <p:spPr>
          <a:xfrm>
            <a:off x="9945102" y="4790656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10014267" y="461752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0145353" y="4397556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0314160" y="4168052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직선 연결선 68"/>
          <p:cNvCxnSpPr/>
          <p:nvPr/>
        </p:nvCxnSpPr>
        <p:spPr>
          <a:xfrm>
            <a:off x="4079626" y="4330662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>
            <a:off x="4079626" y="4632524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4279877" y="4447808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448684" y="4143487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직선 연결선 74"/>
          <p:cNvCxnSpPr/>
          <p:nvPr/>
        </p:nvCxnSpPr>
        <p:spPr>
          <a:xfrm>
            <a:off x="1198993" y="4326336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/>
          <p:cNvCxnSpPr/>
          <p:nvPr/>
        </p:nvCxnSpPr>
        <p:spPr>
          <a:xfrm>
            <a:off x="1198993" y="455338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직선 연결선 76"/>
          <p:cNvCxnSpPr/>
          <p:nvPr/>
        </p:nvCxnSpPr>
        <p:spPr>
          <a:xfrm>
            <a:off x="1198993" y="4761765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1268158" y="4588632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399244" y="4368665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568051" y="4139161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4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158712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/>
          <p:cNvGrpSpPr/>
          <p:nvPr/>
        </p:nvGrpSpPr>
        <p:grpSpPr>
          <a:xfrm>
            <a:off x="422392" y="1593339"/>
            <a:ext cx="5408444" cy="4029845"/>
            <a:chOff x="505516" y="1210953"/>
            <a:chExt cx="5408444" cy="4029845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815384" y="1432055"/>
              <a:ext cx="1680787" cy="1665331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14795" y="1432055"/>
              <a:ext cx="1680787" cy="1665331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232682" y="1432056"/>
              <a:ext cx="1681278" cy="1661728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815384" y="3279730"/>
              <a:ext cx="1679914" cy="1668194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519669" y="3279730"/>
              <a:ext cx="1675457" cy="1658229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231727" y="3279731"/>
              <a:ext cx="1680787" cy="1661728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504972" y="1210953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204383" y="1210953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922537" y="1210953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04495" y="3064447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167070" y="3064447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882042" y="3064447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m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직선 화살표 연결선 19"/>
            <p:cNvCxnSpPr/>
            <p:nvPr/>
          </p:nvCxnSpPr>
          <p:spPr>
            <a:xfrm flipV="1">
              <a:off x="655999" y="5077674"/>
              <a:ext cx="259553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직선 화살표 연결선 20"/>
            <p:cNvCxnSpPr/>
            <p:nvPr/>
          </p:nvCxnSpPr>
          <p:spPr>
            <a:xfrm rot="16200000" flipV="1">
              <a:off x="-312594" y="4114909"/>
              <a:ext cx="1944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3347430" y="4933021"/>
              <a:ext cx="23757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M-H2DCFDA (FITC-ROS)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123841" y="2414804"/>
              <a:ext cx="10711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count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276653" y="851103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266439" y="851103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26" name="그룹 25"/>
          <p:cNvGrpSpPr/>
          <p:nvPr/>
        </p:nvGrpSpPr>
        <p:grpSpPr>
          <a:xfrm>
            <a:off x="6936335" y="4173336"/>
            <a:ext cx="4840030" cy="2366696"/>
            <a:chOff x="2539824" y="1728724"/>
            <a:chExt cx="5310875" cy="2619907"/>
          </a:xfrm>
        </p:grpSpPr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 xmlns="">
                    <a14:imgLayer r:embed="rId9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539824" y="1728724"/>
              <a:ext cx="1260000" cy="1260000"/>
            </a:xfrm>
            <a:prstGeom prst="rect">
              <a:avLst/>
            </a:prstGeom>
          </p:spPr>
        </p:pic>
        <p:pic>
          <p:nvPicPr>
            <p:cNvPr id="28" name="그림 27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 xmlns="">
                    <a14:imgLayer r:embed="rId11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90116" y="1728725"/>
              <a:ext cx="1260000" cy="1260000"/>
            </a:xfrm>
            <a:prstGeom prst="rect">
              <a:avLst/>
            </a:prstGeom>
          </p:spPr>
        </p:pic>
        <p:pic>
          <p:nvPicPr>
            <p:cNvPr id="29" name="그림 28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 xmlns="">
                    <a14:imgLayer r:embed="rId13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0408" y="1728725"/>
              <a:ext cx="1260000" cy="1260000"/>
            </a:xfrm>
            <a:prstGeom prst="rect">
              <a:avLst/>
            </a:prstGeom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 xmlns="">
                    <a14:imgLayer r:embed="rId15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590699" y="1728724"/>
              <a:ext cx="1260000" cy="1260000"/>
            </a:xfrm>
            <a:prstGeom prst="rect">
              <a:avLst/>
            </a:prstGeom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 xmlns="">
                    <a14:imgLayer r:embed="rId17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881829" y="3088631"/>
              <a:ext cx="1260000" cy="1260000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 xmlns="">
                    <a14:imgLayer r:embed="rId19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0408" y="3088631"/>
              <a:ext cx="1260000" cy="1260000"/>
            </a:xfrm>
            <a:prstGeom prst="rect">
              <a:avLst/>
            </a:prstGeom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 xmlns="">
                    <a14:imgLayer r:embed="rId21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590699" y="3088631"/>
              <a:ext cx="1260000" cy="1260000"/>
            </a:xfrm>
            <a:prstGeom prst="rect">
              <a:avLst/>
            </a:prstGeom>
          </p:spPr>
        </p:pic>
      </p:grpSp>
      <p:sp>
        <p:nvSpPr>
          <p:cNvPr id="35" name="TextBox 34"/>
          <p:cNvSpPr txBox="1"/>
          <p:nvPr/>
        </p:nvSpPr>
        <p:spPr>
          <a:xfrm>
            <a:off x="6266439" y="3915094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939615" y="417333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163431" y="418719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9396481" y="418257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629531" y="418719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168040" y="541100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9401093" y="541562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0643383" y="541101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0m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580321" y="5418651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20x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직사각형 43"/>
          <p:cNvSpPr>
            <a:spLocks/>
          </p:cNvSpPr>
          <p:nvPr/>
        </p:nvSpPr>
        <p:spPr>
          <a:xfrm>
            <a:off x="908623" y="1195741"/>
            <a:ext cx="162802" cy="162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45" name="직사각형 44"/>
          <p:cNvSpPr>
            <a:spLocks/>
          </p:cNvSpPr>
          <p:nvPr/>
        </p:nvSpPr>
        <p:spPr>
          <a:xfrm>
            <a:off x="2213626" y="1195741"/>
            <a:ext cx="162802" cy="162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46" name="TextBox 45"/>
          <p:cNvSpPr txBox="1"/>
          <p:nvPr/>
        </p:nvSpPr>
        <p:spPr>
          <a:xfrm>
            <a:off x="1088918" y="1115255"/>
            <a:ext cx="1111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ko-KR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398591" y="1113917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직사각형 47"/>
          <p:cNvSpPr>
            <a:spLocks/>
          </p:cNvSpPr>
          <p:nvPr/>
        </p:nvSpPr>
        <p:spPr>
          <a:xfrm>
            <a:off x="3042770" y="1195741"/>
            <a:ext cx="162802" cy="162000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49" name="TextBox 48"/>
          <p:cNvSpPr txBox="1"/>
          <p:nvPr/>
        </p:nvSpPr>
        <p:spPr>
          <a:xfrm>
            <a:off x="3232395" y="1113917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M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그림 1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638314" y="1007909"/>
            <a:ext cx="3832225" cy="2759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0" name="TextBox 49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5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397544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그룹 47"/>
          <p:cNvGrpSpPr/>
          <p:nvPr/>
        </p:nvGrpSpPr>
        <p:grpSpPr>
          <a:xfrm>
            <a:off x="2092093" y="3568745"/>
            <a:ext cx="8744227" cy="3502479"/>
            <a:chOff x="2296810" y="-252632"/>
            <a:chExt cx="8744227" cy="3502479"/>
          </a:xfrm>
        </p:grpSpPr>
        <p:grpSp>
          <p:nvGrpSpPr>
            <p:cNvPr id="47" name="그룹 46"/>
            <p:cNvGrpSpPr/>
            <p:nvPr/>
          </p:nvGrpSpPr>
          <p:grpSpPr>
            <a:xfrm>
              <a:off x="2296810" y="-252632"/>
              <a:ext cx="5638143" cy="3502479"/>
              <a:chOff x="2296810" y="-252632"/>
              <a:chExt cx="5638143" cy="3502479"/>
            </a:xfrm>
          </p:grpSpPr>
          <p:graphicFrame>
            <p:nvGraphicFramePr>
              <p:cNvPr id="3" name="차트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191847139"/>
                  </p:ext>
                </p:extLst>
              </p:nvPr>
            </p:nvGraphicFramePr>
            <p:xfrm>
              <a:off x="2296810" y="-252632"/>
              <a:ext cx="5537006" cy="350247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직사각형 3"/>
              <p:cNvSpPr/>
              <p:nvPr/>
            </p:nvSpPr>
            <p:spPr>
              <a:xfrm>
                <a:off x="2893666" y="2935947"/>
                <a:ext cx="5041287" cy="29916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7648351" y="-184393"/>
              <a:ext cx="3392686" cy="2461535"/>
              <a:chOff x="6938667" y="560983"/>
              <a:chExt cx="3392686" cy="2461535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6938667" y="560983"/>
                <a:ext cx="261476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gative control (olive</a:t>
                </a:r>
                <a:r>
                  <a:rPr lang="ko-KR" alt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il)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6938667" y="997719"/>
                <a:ext cx="205520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AG 500 mg/kg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6938667" y="1420607"/>
                <a:ext cx="2328161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mcitabine 80 mg/kg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6938667" y="1876876"/>
                <a:ext cx="326075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AG/Gemcitabine 500/80 mg/kg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938667" y="2295762"/>
                <a:ext cx="2874071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emcitabine 120 mg/kg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938667" y="2714741"/>
                <a:ext cx="339268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AG/Gemcitabine 500/120 mg/kg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8" name="그룹 97"/>
          <p:cNvGrpSpPr/>
          <p:nvPr/>
        </p:nvGrpSpPr>
        <p:grpSpPr>
          <a:xfrm>
            <a:off x="2770512" y="565549"/>
            <a:ext cx="5835855" cy="2595516"/>
            <a:chOff x="2756864" y="333533"/>
            <a:chExt cx="5835855" cy="2595516"/>
          </a:xfrm>
        </p:grpSpPr>
        <p:cxnSp>
          <p:nvCxnSpPr>
            <p:cNvPr id="49" name="직선 연결선 48"/>
            <p:cNvCxnSpPr/>
            <p:nvPr/>
          </p:nvCxnSpPr>
          <p:spPr>
            <a:xfrm>
              <a:off x="3297237" y="1828384"/>
              <a:ext cx="468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>
              <a:off x="3289118" y="1641810"/>
              <a:ext cx="0" cy="360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4506049" y="1641810"/>
              <a:ext cx="0" cy="360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6787503" y="1641810"/>
              <a:ext cx="0" cy="360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화살표 연결선 69"/>
            <p:cNvCxnSpPr/>
            <p:nvPr/>
          </p:nvCxnSpPr>
          <p:spPr>
            <a:xfrm flipV="1">
              <a:off x="4490128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화살표 연결선 70"/>
            <p:cNvCxnSpPr/>
            <p:nvPr/>
          </p:nvCxnSpPr>
          <p:spPr>
            <a:xfrm flipV="1">
              <a:off x="4783556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화살표 연결선 71"/>
            <p:cNvCxnSpPr/>
            <p:nvPr/>
          </p:nvCxnSpPr>
          <p:spPr>
            <a:xfrm flipV="1">
              <a:off x="5076984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화살표 연결선 72"/>
            <p:cNvCxnSpPr/>
            <p:nvPr/>
          </p:nvCxnSpPr>
          <p:spPr>
            <a:xfrm flipV="1">
              <a:off x="5370412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화살표 연결선 73"/>
            <p:cNvCxnSpPr/>
            <p:nvPr/>
          </p:nvCxnSpPr>
          <p:spPr>
            <a:xfrm flipV="1">
              <a:off x="5663840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직선 화살표 연결선 74"/>
            <p:cNvCxnSpPr/>
            <p:nvPr/>
          </p:nvCxnSpPr>
          <p:spPr>
            <a:xfrm flipV="1">
              <a:off x="5957268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화살표 연결선 75"/>
            <p:cNvCxnSpPr/>
            <p:nvPr/>
          </p:nvCxnSpPr>
          <p:spPr>
            <a:xfrm flipV="1">
              <a:off x="6250696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직선 화살표 연결선 76"/>
            <p:cNvCxnSpPr/>
            <p:nvPr/>
          </p:nvCxnSpPr>
          <p:spPr>
            <a:xfrm flipV="1">
              <a:off x="6544125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4842938" y="2281702"/>
              <a:ext cx="140775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emotherapy </a:t>
              </a:r>
            </a:p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Gemcitabine)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138994" y="132838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314982" y="132838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6582788" y="132838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직선 화살표 연결선 81"/>
            <p:cNvCxnSpPr/>
            <p:nvPr/>
          </p:nvCxnSpPr>
          <p:spPr>
            <a:xfrm>
              <a:off x="4487440" y="1082451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화살표 연결선 82"/>
            <p:cNvCxnSpPr/>
            <p:nvPr/>
          </p:nvCxnSpPr>
          <p:spPr>
            <a:xfrm>
              <a:off x="4639840" y="1082451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직선 화살표 연결선 83"/>
            <p:cNvCxnSpPr/>
            <p:nvPr/>
          </p:nvCxnSpPr>
          <p:spPr>
            <a:xfrm>
              <a:off x="4805888" y="1082451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직선 화살표 연결선 84"/>
            <p:cNvCxnSpPr/>
            <p:nvPr/>
          </p:nvCxnSpPr>
          <p:spPr>
            <a:xfrm>
              <a:off x="4958288" y="1082451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직선 화살표 연결선 86"/>
            <p:cNvCxnSpPr/>
            <p:nvPr/>
          </p:nvCxnSpPr>
          <p:spPr>
            <a:xfrm>
              <a:off x="6457273" y="1084724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직선 화살표 연결선 87"/>
            <p:cNvCxnSpPr/>
            <p:nvPr/>
          </p:nvCxnSpPr>
          <p:spPr>
            <a:xfrm>
              <a:off x="6623321" y="1084724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직선 화살표 연결선 88"/>
            <p:cNvCxnSpPr/>
            <p:nvPr/>
          </p:nvCxnSpPr>
          <p:spPr>
            <a:xfrm>
              <a:off x="6775721" y="1084724"/>
              <a:ext cx="0" cy="21600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prstDash val="sysDot"/>
              <a:headEnd type="none" w="med" len="med"/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5427237" y="1010556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·····</a:t>
              </a:r>
              <a:endParaRPr lang="ko-KR" altLang="en-US" dirty="0"/>
            </a:p>
          </p:txBody>
        </p:sp>
        <p:sp>
          <p:nvSpPr>
            <p:cNvPr id="91" name="왼쪽 중괄호 90"/>
            <p:cNvSpPr/>
            <p:nvPr/>
          </p:nvSpPr>
          <p:spPr>
            <a:xfrm rot="5400000">
              <a:off x="5576238" y="-220913"/>
              <a:ext cx="146052" cy="2307504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92" name="직선 화살표 연결선 91"/>
            <p:cNvCxnSpPr/>
            <p:nvPr/>
          </p:nvCxnSpPr>
          <p:spPr>
            <a:xfrm flipV="1">
              <a:off x="3277750" y="2015458"/>
              <a:ext cx="0" cy="2910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2756864" y="2281702"/>
              <a:ext cx="108074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MI8226 </a:t>
              </a:r>
            </a:p>
            <a:p>
              <a:pPr algn="ctr"/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jection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직선 화살표 연결선 93"/>
            <p:cNvCxnSpPr/>
            <p:nvPr/>
          </p:nvCxnSpPr>
          <p:spPr>
            <a:xfrm flipV="1">
              <a:off x="6764765" y="2017729"/>
              <a:ext cx="0" cy="43200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ash"/>
              <a:tailEnd type="arrow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6250696" y="2405829"/>
              <a:ext cx="141737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st measured </a:t>
              </a:r>
            </a:p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 weights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599847" y="333533"/>
              <a:ext cx="206498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AG (or Olive oil) </a:t>
              </a:r>
            </a:p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o. administration daily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7970433" y="1658127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ay)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9" name="TextBox 98"/>
          <p:cNvSpPr txBox="1"/>
          <p:nvPr/>
        </p:nvSpPr>
        <p:spPr>
          <a:xfrm>
            <a:off x="1750613" y="523555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750612" y="3266959"/>
            <a:ext cx="3921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4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33971" y="138477"/>
            <a:ext cx="2279902" cy="224334"/>
          </a:xfrm>
          <a:prstGeom prst="rect">
            <a:avLst/>
          </a:prstGeom>
          <a:noFill/>
        </p:spPr>
        <p:txBody>
          <a:bodyPr wrap="square" lIns="8805" tIns="4402" rIns="8805" bIns="4402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igure </a:t>
            </a:r>
            <a:r>
              <a:rPr lang="en-US" altLang="ko-KR" sz="1400" b="1" dirty="0" err="1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6</a:t>
            </a:r>
            <a:r>
              <a:rPr lang="en-US" altLang="ko-KR" sz="1400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. </a:t>
            </a:r>
            <a:endParaRPr lang="ko-KR" altLang="en-US" sz="14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71692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45</TotalTime>
  <Words>411</Words>
  <Application>Microsoft Office PowerPoint</Application>
  <PresentationFormat>Custom</PresentationFormat>
  <Paragraphs>228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테마</vt:lpstr>
      <vt:lpstr>Prism Project</vt:lpstr>
      <vt:lpstr>Slide 1</vt:lpstr>
      <vt:lpstr>Slide 2</vt:lpstr>
      <vt:lpstr>Slide 3</vt:lpstr>
      <vt:lpstr>Slide 4</vt:lpstr>
      <vt:lpstr>Slide 5</vt:lpstr>
      <vt:lpstr>Slide 6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진선</dc:creator>
  <cp:lastModifiedBy>0013357</cp:lastModifiedBy>
  <cp:revision>119</cp:revision>
  <cp:lastPrinted>2018-04-05T02:47:46Z</cp:lastPrinted>
  <dcterms:created xsi:type="dcterms:W3CDTF">2017-06-20T00:32:24Z</dcterms:created>
  <dcterms:modified xsi:type="dcterms:W3CDTF">2018-12-26T13:15:10Z</dcterms:modified>
</cp:coreProperties>
</file>